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3"/>
    <p:restoredTop sz="94659"/>
  </p:normalViewPr>
  <p:slideViewPr>
    <p:cSldViewPr snapToGrid="0" snapToObjects="1">
      <p:cViewPr varScale="1">
        <p:scale>
          <a:sx n="146" d="100"/>
          <a:sy n="146" d="100"/>
        </p:scale>
        <p:origin x="9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C893AF-C8C3-D74B-8C3D-7DB69A17B659}" type="datetimeFigureOut">
              <a:rPr lang="en-US" smtClean="0"/>
              <a:t>5/3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E8A14B-4CEC-C245-83EF-ADEA1E6E9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7949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838999-620D-994D-B93C-D668C0FB047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5066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870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920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378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068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3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974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736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978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25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99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920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231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628650" y="365126"/>
            <a:ext cx="7770883" cy="306513"/>
          </a:xfrm>
        </p:spPr>
        <p:txBody>
          <a:bodyPr>
            <a:normAutofit/>
          </a:bodyPr>
          <a:lstStyle/>
          <a:p>
            <a:r>
              <a:rPr lang="en-US" sz="1400" dirty="0" smtClean="0">
                <a:latin typeface="Times New Roman" charset="0"/>
                <a:ea typeface="Times New Roman" charset="0"/>
                <a:cs typeface="Times New Roman" charset="0"/>
              </a:rPr>
              <a:t>Supplementary Table 1: Information on the macaques used in this study</a:t>
            </a:r>
            <a:endParaRPr lang="en-US" sz="14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4102850"/>
              </p:ext>
            </p:extLst>
          </p:nvPr>
        </p:nvGraphicFramePr>
        <p:xfrm>
          <a:off x="226577" y="968880"/>
          <a:ext cx="8755582" cy="567300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65847"/>
                <a:gridCol w="890124"/>
                <a:gridCol w="4368453"/>
                <a:gridCol w="2234648"/>
                <a:gridCol w="396510"/>
              </a:tblGrid>
              <a:tr h="552368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Cohort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Number of animal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Treatment history of</a:t>
                      </a:r>
                      <a:r>
                        <a:rPr lang="en-US" sz="1200" baseline="0" dirty="0" smtClean="0"/>
                        <a:t> the animal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Animals</a:t>
                      </a:r>
                      <a:r>
                        <a:rPr lang="en-US" sz="1200" baseline="0" dirty="0" smtClean="0"/>
                        <a:t> used in Figures/supplemental Figure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Refs</a:t>
                      </a:r>
                      <a:endParaRPr lang="en-US" sz="1200" dirty="0"/>
                    </a:p>
                  </a:txBody>
                  <a:tcPr/>
                </a:tc>
              </a:tr>
              <a:tr h="447491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40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Naïve</a:t>
                      </a:r>
                      <a:r>
                        <a:rPr lang="en-US" sz="1200" baseline="0" dirty="0" smtClean="0"/>
                        <a:t> animals.  PBMCs from this cohort of animals were obtained to compared with those from the SIV-infected animals.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Figure 2C-purple squares</a:t>
                      </a:r>
                    </a:p>
                    <a:p>
                      <a:r>
                        <a:rPr lang="en-US" sz="1200" dirty="0" smtClean="0"/>
                        <a:t>Figure 7-pre-infected plasma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  <a:tr h="802638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-A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hese 12 animals were part</a:t>
                      </a:r>
                      <a:r>
                        <a:rPr lang="en-US" sz="1200" kern="1200" baseline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of cohort 1. </a:t>
                      </a:r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he animals were </a:t>
                      </a:r>
                      <a:r>
                        <a:rPr lang="en-US" sz="120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trarectally</a:t>
                      </a:r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challenged by three serial SIVmac251 viruses at 2-week intervals until they have been infected. </a:t>
                      </a:r>
                      <a:r>
                        <a:rPr lang="en-US" sz="1200" kern="1200" baseline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About 14 months post-infection, all 12 animals were necropsied. The rest of the animals from this cohort were necropsied 6 months post-infections.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Figure 1-3, 5-9</a:t>
                      </a:r>
                    </a:p>
                    <a:p>
                      <a:r>
                        <a:rPr lang="en-US" sz="1200" baseline="0" dirty="0" smtClean="0"/>
                        <a:t>S1-S8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  <a:tr h="802638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8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Naïve</a:t>
                      </a:r>
                      <a:r>
                        <a:rPr lang="en-US" sz="1200" baseline="0" dirty="0" smtClean="0"/>
                        <a:t> animals. The PBMC and Bone marrow were obtained to compared with those from the SIV, and SHIV-infected animals.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Figure  2C&amp;E-orenge</a:t>
                      </a:r>
                      <a:r>
                        <a:rPr lang="en-US" sz="1200" baseline="0" dirty="0" smtClean="0"/>
                        <a:t> squares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Figure  8B&amp;C-Black</a:t>
                      </a:r>
                      <a:r>
                        <a:rPr lang="en-US" sz="1200" baseline="0" dirty="0" smtClean="0"/>
                        <a:t> dots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aseline="0" dirty="0" smtClean="0"/>
                        <a:t>Figure 6, S6 &amp;S7 naïve bone marrow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  <a:tr h="802638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-A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2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hese 12 animals were part</a:t>
                      </a:r>
                      <a:r>
                        <a:rPr lang="en-US" sz="1200" kern="1200" baseline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of cohort 12. </a:t>
                      </a:r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he animals were </a:t>
                      </a:r>
                      <a:r>
                        <a:rPr lang="en-US" sz="120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trarectally</a:t>
                      </a:r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exposed to </a:t>
                      </a:r>
                      <a:r>
                        <a:rPr lang="en-US" sz="1200" b="1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</a:t>
                      </a:r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serial SHIVSF162P4 viral challenges with a week of interval (1:35 dilution) until they were infected. </a:t>
                      </a:r>
                      <a:r>
                        <a:rPr lang="en-US" sz="1200" kern="1200" baseline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About 14 months post-infection, all 12 animals were necropsied. The rest of the animals from </a:t>
                      </a:r>
                      <a:r>
                        <a:rPr lang="en-US" sz="1200" kern="1200" baseline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his cohort are still alive.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Figure 4, 8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  <a:tr h="624274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3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Naïve animals</a:t>
                      </a:r>
                      <a:r>
                        <a:rPr lang="en-US" sz="1200" baseline="0" dirty="0" smtClean="0"/>
                        <a:t>. Bone marrow samples from this cohort of animals were obtained to compared with those from the SIV-infected animals.  </a:t>
                      </a:r>
                      <a:endParaRPr lang="en-US" sz="12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Figure  2E-orenge</a:t>
                      </a:r>
                      <a:r>
                        <a:rPr lang="en-US" sz="1200" baseline="0" dirty="0" smtClean="0"/>
                        <a:t> squares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Figure  8B&amp;C-orenge</a:t>
                      </a:r>
                      <a:r>
                        <a:rPr lang="en-US" sz="1200" baseline="0" dirty="0" smtClean="0"/>
                        <a:t> dot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  <a:tr h="599675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Other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8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Liver single suspension cells from</a:t>
                      </a:r>
                      <a:r>
                        <a:rPr lang="en-US" sz="1200" baseline="0" dirty="0" smtClean="0"/>
                        <a:t> 4 </a:t>
                      </a:r>
                      <a:r>
                        <a:rPr lang="en-US" sz="1200" baseline="0" smtClean="0"/>
                        <a:t>naïve, and 4 normal (adenovirus-exposed, SIV/SIHV-negative) animals. </a:t>
                      </a:r>
                      <a:endParaRPr lang="en-US" sz="1200" baseline="0" dirty="0" smtClean="0"/>
                    </a:p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aseline="0" dirty="0" smtClean="0"/>
                        <a:t>Figure 2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  <a:tr h="339865">
                <a:tc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6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SIV-infected bone</a:t>
                      </a:r>
                      <a:r>
                        <a:rPr lang="en-US" sz="1200" baseline="0" dirty="0" smtClean="0"/>
                        <a:t> marrow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aseline="0" dirty="0" smtClean="0"/>
                        <a:t>Figure 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629146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2</TotalTime>
  <Words>276</Words>
  <Application>Microsoft Macintosh PowerPoint</Application>
  <PresentationFormat>On-screen Show (4:3)</PresentationFormat>
  <Paragraphs>3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Supplementary Table 1: Information on the macaques used in this study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Table 1. Spearman’s R values between the CM9 tetramer+CD8+T cell percentages of different compartments  </dc:title>
  <dc:creator>Microsoft Office User</dc:creator>
  <cp:lastModifiedBy>Yongjun Sui</cp:lastModifiedBy>
  <cp:revision>25</cp:revision>
  <cp:lastPrinted>2016-12-02T20:14:24Z</cp:lastPrinted>
  <dcterms:created xsi:type="dcterms:W3CDTF">2016-11-21T15:15:29Z</dcterms:created>
  <dcterms:modified xsi:type="dcterms:W3CDTF">2017-05-03T19:21:42Z</dcterms:modified>
</cp:coreProperties>
</file>